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9456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2" pos="28" userDrawn="1">
          <p15:clr>
            <a:srgbClr val="A4A3A4"/>
          </p15:clr>
        </p15:guide>
        <p15:guide id="3" pos="3657">
          <p15:clr>
            <a:srgbClr val="A4A3A4"/>
          </p15:clr>
        </p15:guide>
        <p15:guide id="4" pos="2840">
          <p15:clr>
            <a:srgbClr val="A4A3A4"/>
          </p15:clr>
        </p15:guide>
        <p15:guide id="5" pos="2614">
          <p15:clr>
            <a:srgbClr val="A4A3A4"/>
          </p15:clr>
        </p15:guide>
        <p15:guide id="6" pos="2160" userDrawn="1">
          <p15:clr>
            <a:srgbClr val="A4A3A4"/>
          </p15:clr>
        </p15:guide>
        <p15:guide id="7" pos="4020" userDrawn="1">
          <p15:clr>
            <a:srgbClr val="A4A3A4"/>
          </p15:clr>
        </p15:guide>
        <p15:guide id="8" orient="horz" pos="28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 showGuides="1">
      <p:cViewPr>
        <p:scale>
          <a:sx n="125" d="100"/>
          <a:sy n="125" d="100"/>
        </p:scale>
        <p:origin x="-2910" y="-72"/>
      </p:cViewPr>
      <p:guideLst>
        <p:guide orient="horz" pos="2835"/>
        <p:guide pos="28"/>
        <p:guide pos="3657"/>
        <p:guide pos="2840"/>
        <p:guide pos="2614"/>
        <p:guide pos="2160"/>
        <p:guide pos="40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80110-D1E3-45AA-9D32-8DD481D1B163}" type="datetimeFigureOut">
              <a:rPr lang="en-GB" smtClean="0"/>
              <a:t>17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E6547-4041-4827-A0B5-88D0EEDB2E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2282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80110-D1E3-45AA-9D32-8DD481D1B163}" type="datetimeFigureOut">
              <a:rPr lang="en-GB" smtClean="0"/>
              <a:t>17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E6547-4041-4827-A0B5-88D0EEDB2E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2355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80110-D1E3-45AA-9D32-8DD481D1B163}" type="datetimeFigureOut">
              <a:rPr lang="en-GB" smtClean="0"/>
              <a:t>17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E6547-4041-4827-A0B5-88D0EEDB2E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56350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80110-D1E3-45AA-9D32-8DD481D1B163}" type="datetimeFigureOut">
              <a:rPr lang="en-GB" smtClean="0"/>
              <a:t>17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E6547-4041-4827-A0B5-88D0EEDB2E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28264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80110-D1E3-45AA-9D32-8DD481D1B163}" type="datetimeFigureOut">
              <a:rPr lang="en-GB" smtClean="0"/>
              <a:t>17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E6547-4041-4827-A0B5-88D0EEDB2E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40722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80110-D1E3-45AA-9D32-8DD481D1B163}" type="datetimeFigureOut">
              <a:rPr lang="en-GB" smtClean="0"/>
              <a:t>17/10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E6547-4041-4827-A0B5-88D0EEDB2E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2266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80110-D1E3-45AA-9D32-8DD481D1B163}" type="datetimeFigureOut">
              <a:rPr lang="en-GB" smtClean="0"/>
              <a:t>17/10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E6547-4041-4827-A0B5-88D0EEDB2E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40346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80110-D1E3-45AA-9D32-8DD481D1B163}" type="datetimeFigureOut">
              <a:rPr lang="en-GB" smtClean="0"/>
              <a:t>17/10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E6547-4041-4827-A0B5-88D0EEDB2E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66476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80110-D1E3-45AA-9D32-8DD481D1B163}" type="datetimeFigureOut">
              <a:rPr lang="en-GB" smtClean="0"/>
              <a:t>17/10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E6547-4041-4827-A0B5-88D0EEDB2E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8888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80110-D1E3-45AA-9D32-8DD481D1B163}" type="datetimeFigureOut">
              <a:rPr lang="en-GB" smtClean="0"/>
              <a:t>17/10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E6547-4041-4827-A0B5-88D0EEDB2E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28310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80110-D1E3-45AA-9D32-8DD481D1B163}" type="datetimeFigureOut">
              <a:rPr lang="en-GB" smtClean="0"/>
              <a:t>17/10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E6547-4041-4827-A0B5-88D0EEDB2E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1596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180110-D1E3-45AA-9D32-8DD481D1B163}" type="datetimeFigureOut">
              <a:rPr lang="en-GB" smtClean="0"/>
              <a:t>17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E6547-4041-4827-A0B5-88D0EEDB2E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75383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04664" y="171450"/>
            <a:ext cx="4896544" cy="322127"/>
          </a:xfrm>
        </p:spPr>
        <p:txBody>
          <a:bodyPr>
            <a:noAutofit/>
          </a:bodyPr>
          <a:lstStyle/>
          <a:p>
            <a:pPr algn="l"/>
            <a:r>
              <a:rPr lang="en-GB" sz="1600" b="1" dirty="0" smtClean="0"/>
              <a:t>Categorisation of Mobile EEG (</a:t>
            </a:r>
            <a:r>
              <a:rPr lang="en-GB" sz="1600" b="1" dirty="0" err="1" smtClean="0"/>
              <a:t>CoME</a:t>
            </a:r>
            <a:r>
              <a:rPr lang="en-GB" sz="1600" b="1" dirty="0" smtClean="0"/>
              <a:t>)</a:t>
            </a:r>
            <a:endParaRPr lang="en-GB" sz="1600" b="1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76250" y="444500"/>
            <a:ext cx="5905078" cy="1755097"/>
          </a:xfrm>
          <a:ln w="12700">
            <a:solidFill>
              <a:schemeClr val="tx1"/>
            </a:solidFill>
          </a:ln>
        </p:spPr>
        <p:txBody>
          <a:bodyPr>
            <a:noAutofit/>
          </a:bodyPr>
          <a:lstStyle/>
          <a:p>
            <a:pPr algn="l"/>
            <a:r>
              <a:rPr lang="en-GB" sz="1000" b="1" dirty="0" smtClean="0">
                <a:solidFill>
                  <a:schemeClr val="tx1"/>
                </a:solidFill>
              </a:rPr>
              <a:t>Instructions: </a:t>
            </a:r>
            <a:r>
              <a:rPr lang="en-GB" sz="1000" dirty="0" smtClean="0">
                <a:solidFill>
                  <a:schemeClr val="tx1"/>
                </a:solidFill>
              </a:rPr>
              <a:t>Complete Sections 1, 2, 3 and 4 to score Device Mobility (D), Participant Mobility (P), System Specification (S), and Number of Channels respectively. </a:t>
            </a:r>
          </a:p>
          <a:p>
            <a:pPr algn="l"/>
            <a:r>
              <a:rPr lang="en-GB" sz="1000" dirty="0" smtClean="0">
                <a:solidFill>
                  <a:schemeClr val="tx1"/>
                </a:solidFill>
              </a:rPr>
              <a:t>For each category, select the most appropriate descriptor for your mobile EEG study and EEG system. Circle the score next to the selected descriptor for D and P.</a:t>
            </a:r>
          </a:p>
          <a:p>
            <a:pPr algn="l"/>
            <a:r>
              <a:rPr lang="en-GB" sz="1000" dirty="0" smtClean="0">
                <a:solidFill>
                  <a:schemeClr val="tx1"/>
                </a:solidFill>
              </a:rPr>
              <a:t>For the system specification (S), separately record scores for bit resolution, sampling rate, battery life and electrode type, and then total these scores to provide a total system specification score. For electrode type score the individual facets such as passive/active etc. and total to give an electrode type score of 1 to 5.</a:t>
            </a:r>
          </a:p>
          <a:p>
            <a:pPr algn="l"/>
            <a:r>
              <a:rPr lang="en-GB" sz="1000" dirty="0" smtClean="0">
                <a:solidFill>
                  <a:schemeClr val="tx1"/>
                </a:solidFill>
              </a:rPr>
              <a:t>In Section 4, just report the number of channels required in the study.</a:t>
            </a:r>
          </a:p>
          <a:p>
            <a:pPr algn="l"/>
            <a:r>
              <a:rPr lang="en-GB" sz="1000" dirty="0" smtClean="0">
                <a:solidFill>
                  <a:schemeClr val="tx1"/>
                </a:solidFill>
              </a:rPr>
              <a:t>In Section 5, transfer the scores from Device </a:t>
            </a:r>
            <a:r>
              <a:rPr lang="en-GB" sz="1000" dirty="0">
                <a:solidFill>
                  <a:schemeClr val="tx1"/>
                </a:solidFill>
              </a:rPr>
              <a:t>M</a:t>
            </a:r>
            <a:r>
              <a:rPr lang="en-GB" sz="1000" dirty="0" smtClean="0">
                <a:solidFill>
                  <a:schemeClr val="tx1"/>
                </a:solidFill>
              </a:rPr>
              <a:t>obility (D), Participant </a:t>
            </a:r>
            <a:r>
              <a:rPr lang="en-GB" sz="1000" dirty="0">
                <a:solidFill>
                  <a:schemeClr val="tx1"/>
                </a:solidFill>
              </a:rPr>
              <a:t>M</a:t>
            </a:r>
            <a:r>
              <a:rPr lang="en-GB" sz="1000" dirty="0" smtClean="0">
                <a:solidFill>
                  <a:schemeClr val="tx1"/>
                </a:solidFill>
              </a:rPr>
              <a:t>obility (P), System Specification (S) and Number of Channels (C) to obtain the final categorisation score.</a:t>
            </a:r>
            <a:endParaRPr lang="en-GB" sz="1000" dirty="0">
              <a:solidFill>
                <a:schemeClr val="tx1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76672" y="8120868"/>
            <a:ext cx="5904656" cy="892552"/>
          </a:xfrm>
          <a:custGeom>
            <a:avLst/>
            <a:gdLst>
              <a:gd name="connsiteX0" fmla="*/ 0 w 2880320"/>
              <a:gd name="connsiteY0" fmla="*/ 0 h 369332"/>
              <a:gd name="connsiteX1" fmla="*/ 2880320 w 2880320"/>
              <a:gd name="connsiteY1" fmla="*/ 0 h 369332"/>
              <a:gd name="connsiteX2" fmla="*/ 2880320 w 2880320"/>
              <a:gd name="connsiteY2" fmla="*/ 369332 h 369332"/>
              <a:gd name="connsiteX3" fmla="*/ 0 w 2880320"/>
              <a:gd name="connsiteY3" fmla="*/ 369332 h 369332"/>
              <a:gd name="connsiteX4" fmla="*/ 0 w 2880320"/>
              <a:gd name="connsiteY4" fmla="*/ 0 h 369332"/>
              <a:gd name="connsiteX0" fmla="*/ 0 w 2880320"/>
              <a:gd name="connsiteY0" fmla="*/ 0 h 2157672"/>
              <a:gd name="connsiteX1" fmla="*/ 2880320 w 2880320"/>
              <a:gd name="connsiteY1" fmla="*/ 0 h 2157672"/>
              <a:gd name="connsiteX2" fmla="*/ 2880320 w 2880320"/>
              <a:gd name="connsiteY2" fmla="*/ 2157672 h 2157672"/>
              <a:gd name="connsiteX3" fmla="*/ 0 w 2880320"/>
              <a:gd name="connsiteY3" fmla="*/ 369332 h 2157672"/>
              <a:gd name="connsiteX4" fmla="*/ 0 w 2880320"/>
              <a:gd name="connsiteY4" fmla="*/ 0 h 2157672"/>
              <a:gd name="connsiteX0" fmla="*/ 0 w 2880320"/>
              <a:gd name="connsiteY0" fmla="*/ 0 h 2157672"/>
              <a:gd name="connsiteX1" fmla="*/ 2880320 w 2880320"/>
              <a:gd name="connsiteY1" fmla="*/ 0 h 2157672"/>
              <a:gd name="connsiteX2" fmla="*/ 2880320 w 2880320"/>
              <a:gd name="connsiteY2" fmla="*/ 2157672 h 2157672"/>
              <a:gd name="connsiteX3" fmla="*/ 0 w 2880320"/>
              <a:gd name="connsiteY3" fmla="*/ 2157672 h 2157672"/>
              <a:gd name="connsiteX4" fmla="*/ 0 w 2880320"/>
              <a:gd name="connsiteY4" fmla="*/ 0 h 215767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880320" h="2157672">
                <a:moveTo>
                  <a:pt x="0" y="0"/>
                </a:moveTo>
                <a:lnTo>
                  <a:pt x="2880320" y="0"/>
                </a:lnTo>
                <a:lnTo>
                  <a:pt x="2880320" y="2157672"/>
                </a:lnTo>
                <a:lnTo>
                  <a:pt x="0" y="2157672"/>
                </a:lnTo>
                <a:lnTo>
                  <a:pt x="0" y="0"/>
                </a:lnTo>
                <a:close/>
              </a:path>
            </a:pathLst>
          </a:custGeom>
          <a:noFill/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600" b="1" u="sng" dirty="0" smtClean="0"/>
              <a:t>Section 5</a:t>
            </a:r>
            <a:r>
              <a:rPr lang="en-GB" sz="1600" b="1" dirty="0" smtClean="0"/>
              <a:t>: Final Categorisation Score:</a:t>
            </a:r>
          </a:p>
          <a:p>
            <a:endParaRPr lang="en-GB" sz="1600" b="1" dirty="0" smtClean="0"/>
          </a:p>
          <a:p>
            <a:pPr algn="ctr"/>
            <a:r>
              <a:rPr lang="en-GB" sz="1600" b="1" dirty="0" smtClean="0"/>
              <a:t>  ( ……….……D</a:t>
            </a:r>
            <a:r>
              <a:rPr lang="en-GB" sz="1600" b="1" dirty="0"/>
              <a:t>, </a:t>
            </a:r>
            <a:r>
              <a:rPr lang="en-GB" sz="1600" b="1" dirty="0" smtClean="0"/>
              <a:t> ……….……</a:t>
            </a:r>
            <a:r>
              <a:rPr lang="en-GB" sz="1600" b="1" dirty="0"/>
              <a:t>P, </a:t>
            </a:r>
            <a:r>
              <a:rPr lang="en-GB" sz="1600" b="1" dirty="0" smtClean="0"/>
              <a:t> ……….……S,  ……….……C )</a:t>
            </a:r>
          </a:p>
          <a:p>
            <a:endParaRPr lang="en-GB" sz="400" dirty="0" smtClean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87265253"/>
              </p:ext>
            </p:extLst>
          </p:nvPr>
        </p:nvGraphicFramePr>
        <p:xfrm>
          <a:off x="476672" y="2954505"/>
          <a:ext cx="5904656" cy="2560237"/>
        </p:xfrm>
        <a:graphic>
          <a:graphicData uri="http://schemas.openxmlformats.org/drawingml/2006/table">
            <a:tbl>
              <a:tblPr firstRow="1" firstCol="1" bandRow="1"/>
              <a:tblGrid>
                <a:gridCol w="288032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57374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6256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270892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2609428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</a:tblGrid>
              <a:tr h="303037">
                <a:tc grid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 u="sng" dirty="0" smtClean="0">
                          <a:effectLst/>
                          <a:latin typeface="+mn-lt"/>
                          <a:ea typeface="Calibri"/>
                          <a:cs typeface="Times New Roman"/>
                        </a:rPr>
                        <a:t>Section 1</a:t>
                      </a:r>
                      <a:r>
                        <a:rPr lang="en-GB" sz="1200" b="1" u="none" dirty="0" smtClean="0">
                          <a:effectLst/>
                          <a:latin typeface="+mn-lt"/>
                          <a:ea typeface="Calibri"/>
                          <a:cs typeface="Times New Roman"/>
                        </a:rPr>
                        <a:t>: </a:t>
                      </a:r>
                      <a:r>
                        <a:rPr lang="en-GB" sz="1200" b="1" dirty="0" smtClean="0">
                          <a:effectLst/>
                          <a:latin typeface="+mn-lt"/>
                          <a:ea typeface="Calibri"/>
                          <a:cs typeface="Times New Roman"/>
                        </a:rPr>
                        <a:t>Device </a:t>
                      </a:r>
                      <a:r>
                        <a:rPr lang="en-GB" sz="1200" b="1" dirty="0">
                          <a:effectLst/>
                          <a:latin typeface="+mn-lt"/>
                          <a:ea typeface="Calibri"/>
                          <a:cs typeface="Times New Roman"/>
                        </a:rPr>
                        <a:t>Mobility Score </a:t>
                      </a:r>
                      <a:r>
                        <a:rPr lang="en-GB" sz="1200" b="1" dirty="0" smtClean="0">
                          <a:effectLst/>
                          <a:latin typeface="+mn-lt"/>
                          <a:ea typeface="Calibri"/>
                          <a:cs typeface="Times New Roman"/>
                        </a:rPr>
                        <a:t>(D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 u="sng" dirty="0" smtClean="0">
                          <a:effectLst/>
                          <a:latin typeface="+mn-lt"/>
                          <a:ea typeface="Calibri"/>
                          <a:cs typeface="Times New Roman"/>
                        </a:rPr>
                        <a:t>Section 2</a:t>
                      </a:r>
                      <a:r>
                        <a:rPr lang="en-GB" sz="1200" b="1" u="none" dirty="0" smtClean="0">
                          <a:effectLst/>
                          <a:latin typeface="+mn-lt"/>
                          <a:ea typeface="Calibri"/>
                          <a:cs typeface="Times New Roman"/>
                        </a:rPr>
                        <a:t>: </a:t>
                      </a:r>
                      <a:r>
                        <a:rPr lang="en-GB" sz="1200" b="1" dirty="0" smtClean="0">
                          <a:effectLst/>
                          <a:latin typeface="+mn-lt"/>
                          <a:ea typeface="Calibri"/>
                          <a:cs typeface="Times New Roman"/>
                        </a:rPr>
                        <a:t>Participant </a:t>
                      </a:r>
                      <a:r>
                        <a:rPr lang="en-GB" sz="1200" b="1" dirty="0">
                          <a:effectLst/>
                          <a:latin typeface="+mn-lt"/>
                          <a:ea typeface="Calibri"/>
                          <a:cs typeface="Times New Roman"/>
                        </a:rPr>
                        <a:t>Mobility Score (P</a:t>
                      </a:r>
                      <a:r>
                        <a:rPr lang="en-GB" sz="1200" b="1" dirty="0" smtClean="0">
                          <a:effectLst/>
                          <a:latin typeface="+mn-lt"/>
                          <a:ea typeface="Calibri"/>
                          <a:cs typeface="Times New Roman"/>
                        </a:rPr>
                        <a:t>)</a:t>
                      </a:r>
                      <a:endParaRPr lang="en-GB" sz="12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en-GB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</a:rPr>
                        <a:t>All equipment off-body mounted and participant tethered via cabling to EEG acquisition equipment.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en-GB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</a:rPr>
                        <a:t>Lying, sitting or standing still. 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endParaRPr lang="en-GB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</a:rPr>
                        <a:t>Waist-mounted (or back-mounted) with additional equipment located in a rucksack. 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endParaRPr lang="en-GB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</a:rPr>
                        <a:t>Lying, sitting or standing with localised movement. 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endParaRPr lang="en-GB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</a:rPr>
                        <a:t>All equipment is waist-mounted.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endParaRPr lang="en-GB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Calibri" panose="020F0502020204030204" pitchFamily="34" charset="0"/>
                        </a:rPr>
                        <a:t>Constrained walking/cycling.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Calibri" panose="020F0502020204030204" pitchFamily="34" charset="0"/>
                        </a:rPr>
                        <a:t>3</a:t>
                      </a:r>
                      <a:endParaRPr lang="en-GB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</a:rPr>
                        <a:t>Head-mounted EEG system, with additional equipment located in a rucksack or off-body. 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Calibri" panose="020F0502020204030204" pitchFamily="34" charset="0"/>
                        </a:rPr>
                        <a:t>3</a:t>
                      </a:r>
                      <a:endParaRPr lang="en-GB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Calibri" panose="020F0502020204030204" pitchFamily="34" charset="0"/>
                        </a:rPr>
                        <a:t>Unconstrained walking/cycling.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Calibri" panose="020F0502020204030204" pitchFamily="34" charset="0"/>
                        </a:rPr>
                        <a:t>4</a:t>
                      </a:r>
                      <a:endParaRPr lang="en-GB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</a:rPr>
                        <a:t>Head-mounted and requires smartphone/tablet.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Calibri" panose="020F0502020204030204" pitchFamily="34" charset="0"/>
                        </a:rPr>
                        <a:t>4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Calibri" panose="020F0502020204030204" pitchFamily="34" charset="0"/>
                        </a:rPr>
                        <a:t>Walking and carrying, climbing stairs, constrained running.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Calibri" panose="020F0502020204030204" pitchFamily="34" charset="0"/>
                        </a:rPr>
                        <a:t>5</a:t>
                      </a:r>
                      <a:endParaRPr lang="en-GB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</a:rPr>
                        <a:t>Head-mounted and does not require any additional equipment.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Calibri" panose="020F0502020204030204" pitchFamily="34" charset="0"/>
                        </a:rPr>
                        <a:t>5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Calibri" panose="020F0502020204030204" pitchFamily="34" charset="0"/>
                        </a:rPr>
                        <a:t>Unconstrained running, vigorous physical exercise </a:t>
                      </a:r>
                      <a:r>
                        <a:rPr lang="en-GB" sz="1000" dirty="0">
                          <a:effectLst/>
                          <a:latin typeface="Calibri" panose="020F0502020204030204" pitchFamily="34" charset="0"/>
                        </a:rPr>
                        <a:t>or </a:t>
                      </a:r>
                      <a:r>
                        <a:rPr lang="en-GB" sz="1000" dirty="0" smtClean="0">
                          <a:effectLst/>
                          <a:latin typeface="Calibri" panose="020F0502020204030204" pitchFamily="34" charset="0"/>
                        </a:rPr>
                        <a:t>sport</a:t>
                      </a:r>
                      <a:r>
                        <a:rPr lang="en-GB" sz="1000" dirty="0">
                          <a:effectLst/>
                          <a:latin typeface="Calibri" panose="020F0502020204030204" pitchFamily="34" charset="0"/>
                        </a:rPr>
                        <a:t>. 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</a:tbl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476672" y="2268365"/>
            <a:ext cx="5904656" cy="276999"/>
          </a:xfrm>
          <a:custGeom>
            <a:avLst/>
            <a:gdLst>
              <a:gd name="connsiteX0" fmla="*/ 0 w 2880320"/>
              <a:gd name="connsiteY0" fmla="*/ 0 h 369332"/>
              <a:gd name="connsiteX1" fmla="*/ 2880320 w 2880320"/>
              <a:gd name="connsiteY1" fmla="*/ 0 h 369332"/>
              <a:gd name="connsiteX2" fmla="*/ 2880320 w 2880320"/>
              <a:gd name="connsiteY2" fmla="*/ 369332 h 369332"/>
              <a:gd name="connsiteX3" fmla="*/ 0 w 2880320"/>
              <a:gd name="connsiteY3" fmla="*/ 369332 h 369332"/>
              <a:gd name="connsiteX4" fmla="*/ 0 w 2880320"/>
              <a:gd name="connsiteY4" fmla="*/ 0 h 369332"/>
              <a:gd name="connsiteX0" fmla="*/ 0 w 2880320"/>
              <a:gd name="connsiteY0" fmla="*/ 0 h 2157672"/>
              <a:gd name="connsiteX1" fmla="*/ 2880320 w 2880320"/>
              <a:gd name="connsiteY1" fmla="*/ 0 h 2157672"/>
              <a:gd name="connsiteX2" fmla="*/ 2880320 w 2880320"/>
              <a:gd name="connsiteY2" fmla="*/ 2157672 h 2157672"/>
              <a:gd name="connsiteX3" fmla="*/ 0 w 2880320"/>
              <a:gd name="connsiteY3" fmla="*/ 369332 h 2157672"/>
              <a:gd name="connsiteX4" fmla="*/ 0 w 2880320"/>
              <a:gd name="connsiteY4" fmla="*/ 0 h 2157672"/>
              <a:gd name="connsiteX0" fmla="*/ 0 w 2880320"/>
              <a:gd name="connsiteY0" fmla="*/ 0 h 2157672"/>
              <a:gd name="connsiteX1" fmla="*/ 2880320 w 2880320"/>
              <a:gd name="connsiteY1" fmla="*/ 0 h 2157672"/>
              <a:gd name="connsiteX2" fmla="*/ 2880320 w 2880320"/>
              <a:gd name="connsiteY2" fmla="*/ 2157672 h 2157672"/>
              <a:gd name="connsiteX3" fmla="*/ 0 w 2880320"/>
              <a:gd name="connsiteY3" fmla="*/ 2157672 h 2157672"/>
              <a:gd name="connsiteX4" fmla="*/ 0 w 2880320"/>
              <a:gd name="connsiteY4" fmla="*/ 0 h 215767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880320" h="2157672">
                <a:moveTo>
                  <a:pt x="0" y="0"/>
                </a:moveTo>
                <a:lnTo>
                  <a:pt x="2880320" y="0"/>
                </a:lnTo>
                <a:lnTo>
                  <a:pt x="2880320" y="2157672"/>
                </a:lnTo>
                <a:lnTo>
                  <a:pt x="0" y="2157672"/>
                </a:lnTo>
                <a:lnTo>
                  <a:pt x="0" y="0"/>
                </a:lnTo>
                <a:close/>
              </a:path>
            </a:pathLst>
          </a:custGeom>
          <a:noFill/>
          <a:ln w="1270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r>
              <a:rPr lang="en-GB" sz="1200" b="1" dirty="0" smtClean="0"/>
              <a:t>Study Title:</a:t>
            </a:r>
            <a:endParaRPr lang="en-GB" sz="12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476672" y="2608738"/>
            <a:ext cx="5904656" cy="276999"/>
          </a:xfrm>
          <a:custGeom>
            <a:avLst/>
            <a:gdLst>
              <a:gd name="connsiteX0" fmla="*/ 0 w 2880320"/>
              <a:gd name="connsiteY0" fmla="*/ 0 h 369332"/>
              <a:gd name="connsiteX1" fmla="*/ 2880320 w 2880320"/>
              <a:gd name="connsiteY1" fmla="*/ 0 h 369332"/>
              <a:gd name="connsiteX2" fmla="*/ 2880320 w 2880320"/>
              <a:gd name="connsiteY2" fmla="*/ 369332 h 369332"/>
              <a:gd name="connsiteX3" fmla="*/ 0 w 2880320"/>
              <a:gd name="connsiteY3" fmla="*/ 369332 h 369332"/>
              <a:gd name="connsiteX4" fmla="*/ 0 w 2880320"/>
              <a:gd name="connsiteY4" fmla="*/ 0 h 369332"/>
              <a:gd name="connsiteX0" fmla="*/ 0 w 2880320"/>
              <a:gd name="connsiteY0" fmla="*/ 0 h 2157672"/>
              <a:gd name="connsiteX1" fmla="*/ 2880320 w 2880320"/>
              <a:gd name="connsiteY1" fmla="*/ 0 h 2157672"/>
              <a:gd name="connsiteX2" fmla="*/ 2880320 w 2880320"/>
              <a:gd name="connsiteY2" fmla="*/ 2157672 h 2157672"/>
              <a:gd name="connsiteX3" fmla="*/ 0 w 2880320"/>
              <a:gd name="connsiteY3" fmla="*/ 369332 h 2157672"/>
              <a:gd name="connsiteX4" fmla="*/ 0 w 2880320"/>
              <a:gd name="connsiteY4" fmla="*/ 0 h 2157672"/>
              <a:gd name="connsiteX0" fmla="*/ 0 w 2880320"/>
              <a:gd name="connsiteY0" fmla="*/ 0 h 2157672"/>
              <a:gd name="connsiteX1" fmla="*/ 2880320 w 2880320"/>
              <a:gd name="connsiteY1" fmla="*/ 0 h 2157672"/>
              <a:gd name="connsiteX2" fmla="*/ 2880320 w 2880320"/>
              <a:gd name="connsiteY2" fmla="*/ 2157672 h 2157672"/>
              <a:gd name="connsiteX3" fmla="*/ 0 w 2880320"/>
              <a:gd name="connsiteY3" fmla="*/ 2157672 h 2157672"/>
              <a:gd name="connsiteX4" fmla="*/ 0 w 2880320"/>
              <a:gd name="connsiteY4" fmla="*/ 0 h 215767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880320" h="2157672">
                <a:moveTo>
                  <a:pt x="0" y="0"/>
                </a:moveTo>
                <a:lnTo>
                  <a:pt x="2880320" y="0"/>
                </a:lnTo>
                <a:lnTo>
                  <a:pt x="2880320" y="2157672"/>
                </a:lnTo>
                <a:lnTo>
                  <a:pt x="0" y="2157672"/>
                </a:lnTo>
                <a:lnTo>
                  <a:pt x="0" y="0"/>
                </a:lnTo>
                <a:close/>
              </a:path>
            </a:pathLst>
          </a:cu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EEG System:</a:t>
            </a: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50684732"/>
              </p:ext>
            </p:extLst>
          </p:nvPr>
        </p:nvGraphicFramePr>
        <p:xfrm>
          <a:off x="476672" y="5578813"/>
          <a:ext cx="5909833" cy="2118901"/>
        </p:xfrm>
        <a:graphic>
          <a:graphicData uri="http://schemas.openxmlformats.org/drawingml/2006/table">
            <a:tbl>
              <a:tblPr firstRow="1" firstCol="1" bandRow="1"/>
              <a:tblGrid>
                <a:gridCol w="27020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974351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02197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032734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204395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610721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352425">
                  <a:extLst>
                    <a:ext uri="{9D8B030D-6E8A-4147-A177-3AD203B41FA5}">
                      <a16:colId xmlns:a16="http://schemas.microsoft.com/office/drawing/2014/main" xmlns="" val="1033841180"/>
                    </a:ext>
                  </a:extLst>
                </a:gridCol>
                <a:gridCol w="361950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351999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235854">
                  <a:extLst>
                    <a:ext uri="{9D8B030D-6E8A-4147-A177-3AD203B41FA5}">
                      <a16:colId xmlns:a16="http://schemas.microsoft.com/office/drawing/2014/main" xmlns="" val="2458090102"/>
                    </a:ext>
                  </a:extLst>
                </a:gridCol>
                <a:gridCol w="493227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</a:tblGrid>
              <a:tr h="256381">
                <a:tc gridSpan="1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1" u="sng" dirty="0" smtClean="0"/>
                        <a:t>Section 3</a:t>
                      </a:r>
                      <a:r>
                        <a:rPr lang="en-GB" sz="1200" b="1" u="none" dirty="0" smtClean="0"/>
                        <a:t>: </a:t>
                      </a:r>
                      <a:r>
                        <a:rPr lang="en-GB" sz="1200" b="1" dirty="0" smtClean="0"/>
                        <a:t>System Specification Score (S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200" b="1" dirty="0" smtClean="0"/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13412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+mn-lt"/>
                          <a:ea typeface="Calibri"/>
                          <a:cs typeface="Times New Roman"/>
                        </a:rPr>
                        <a:t>Bit resolution (bits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+mn-lt"/>
                          <a:ea typeface="Calibri"/>
                          <a:cs typeface="Times New Roman"/>
                        </a:rPr>
                        <a:t>Sampling rate </a:t>
                      </a:r>
                      <a:endParaRPr lang="en-GB" sz="1000" b="1" dirty="0" smtClean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 smtClean="0">
                          <a:effectLst/>
                          <a:latin typeface="+mn-lt"/>
                          <a:ea typeface="Calibri"/>
                          <a:cs typeface="Times New Roman"/>
                        </a:rPr>
                        <a:t>(</a:t>
                      </a:r>
                      <a:r>
                        <a:rPr lang="en-GB" sz="1000" b="1" dirty="0">
                          <a:effectLst/>
                          <a:latin typeface="+mn-lt"/>
                          <a:ea typeface="Calibri"/>
                          <a:cs typeface="Times New Roman"/>
                        </a:rPr>
                        <a:t>Hz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 smtClean="0"/>
                        <a:t>Battery Life </a:t>
                      </a:r>
                    </a:p>
                    <a:p>
                      <a:pPr algn="ctr"/>
                      <a:r>
                        <a:rPr lang="en-GB" sz="1000" b="1" dirty="0" smtClean="0"/>
                        <a:t>(Hrs)</a:t>
                      </a:r>
                      <a:endParaRPr lang="en-GB" sz="1000" b="1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GB" sz="1000" b="1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5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 smtClean="0">
                          <a:effectLst/>
                          <a:latin typeface="+mn-lt"/>
                          <a:ea typeface="Calibri"/>
                          <a:cs typeface="Times New Roman"/>
                        </a:rPr>
                        <a:t>Electrode Type</a:t>
                      </a:r>
                      <a:endParaRPr lang="en-GB" sz="1000" b="1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1" dirty="0" smtClean="0">
                          <a:effectLst/>
                          <a:latin typeface="+mn-lt"/>
                          <a:ea typeface="Times New Roman"/>
                        </a:rPr>
                        <a:t>1</a:t>
                      </a:r>
                      <a:endParaRPr lang="en-GB" sz="1000" b="1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+mn-lt"/>
                          <a:ea typeface="Times New Roman"/>
                        </a:rPr>
                        <a:t>14</a:t>
                      </a:r>
                      <a:endParaRPr lang="en-GB" sz="1000" b="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+mn-lt"/>
                          <a:ea typeface="Times New Roman"/>
                        </a:rPr>
                        <a:t>125 or 128</a:t>
                      </a:r>
                      <a:endParaRPr lang="en-GB" sz="100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b="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/>
                        </a:rPr>
                        <a:t>Mains, USB or equivalent</a:t>
                      </a:r>
                      <a:endParaRPr lang="en-GB" sz="8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0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+mn-lt"/>
                          <a:ea typeface="Times New Roman"/>
                        </a:rPr>
                        <a:t>Passive (0)</a:t>
                      </a:r>
                      <a:endParaRPr lang="en-GB" sz="1000" b="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+mn-lt"/>
                          <a:ea typeface="Times New Roman"/>
                        </a:rPr>
                        <a:t>Active (1)</a:t>
                      </a:r>
                      <a:endParaRPr lang="en-GB" sz="1000" b="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1" dirty="0" smtClean="0">
                          <a:effectLst/>
                          <a:latin typeface="+mn-lt"/>
                          <a:ea typeface="Times New Roman"/>
                        </a:rPr>
                        <a:t>2</a:t>
                      </a:r>
                      <a:endParaRPr lang="en-GB" sz="1000" b="1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+mn-lt"/>
                          <a:ea typeface="Times New Roman"/>
                        </a:rPr>
                        <a:t>16</a:t>
                      </a:r>
                      <a:endParaRPr lang="en-GB" sz="1000" b="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+mn-lt"/>
                          <a:ea typeface="Calibri"/>
                          <a:cs typeface="Times New Roman"/>
                        </a:rPr>
                        <a:t>250 or 256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/>
                        </a:rPr>
                        <a:t>1</a:t>
                      </a:r>
                      <a:r>
                        <a:rPr lang="en-GB" sz="1000" b="0" baseline="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/>
                        </a:rPr>
                        <a:t> </a:t>
                      </a:r>
                      <a:r>
                        <a:rPr lang="en-GB" sz="1000" b="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/>
                        </a:rPr>
                        <a:t>to</a:t>
                      </a:r>
                      <a:r>
                        <a:rPr lang="en-GB" sz="1000" b="0" baseline="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/>
                        </a:rPr>
                        <a:t> 8</a:t>
                      </a:r>
                      <a:endParaRPr lang="en-GB" sz="10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0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+mn-lt"/>
                          <a:ea typeface="Times New Roman"/>
                        </a:rPr>
                        <a:t>Unshielded (0)</a:t>
                      </a:r>
                      <a:endParaRPr lang="en-GB" sz="1000" b="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+mn-lt"/>
                          <a:ea typeface="Times New Roman"/>
                        </a:rPr>
                        <a:t>Shielded (1)</a:t>
                      </a:r>
                      <a:endParaRPr lang="en-GB" sz="1000" b="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1" dirty="0" smtClean="0">
                          <a:effectLst/>
                          <a:latin typeface="+mn-lt"/>
                          <a:ea typeface="Times New Roman"/>
                        </a:rPr>
                        <a:t>3</a:t>
                      </a:r>
                      <a:endParaRPr lang="en-GB" sz="1000" b="1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+mn-lt"/>
                          <a:ea typeface="Times New Roman"/>
                        </a:rPr>
                        <a:t>22</a:t>
                      </a:r>
                      <a:endParaRPr lang="en-GB" sz="1000" b="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+mn-lt"/>
                          <a:ea typeface="Times New Roman"/>
                        </a:rPr>
                        <a:t>500 or 512</a:t>
                      </a:r>
                      <a:endParaRPr lang="en-GB" sz="100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0" baseline="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/>
                        </a:rPr>
                        <a:t>9 to 16</a:t>
                      </a:r>
                      <a:endParaRPr lang="en-GB" sz="10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0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dirty="0" smtClean="0">
                          <a:effectLst/>
                          <a:latin typeface="+mn-lt"/>
                          <a:ea typeface="Times New Roman"/>
                        </a:rPr>
                        <a:t>Dry (1)</a:t>
                      </a:r>
                      <a:endParaRPr lang="en-GB" sz="1000" b="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dirty="0" smtClean="0">
                          <a:effectLst/>
                          <a:latin typeface="+mn-lt"/>
                          <a:ea typeface="Times New Roman"/>
                        </a:rPr>
                        <a:t>Wet (2)</a:t>
                      </a:r>
                      <a:endParaRPr lang="en-GB" sz="1000" b="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dirty="0" smtClean="0">
                          <a:effectLst/>
                          <a:latin typeface="+mn-lt"/>
                          <a:ea typeface="Times New Roman"/>
                        </a:rPr>
                        <a:t>Gel (3)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 smtClean="0">
                          <a:effectLst/>
                          <a:latin typeface="+mn-lt"/>
                          <a:ea typeface="Times New Roman"/>
                        </a:rPr>
                        <a:t>4</a:t>
                      </a:r>
                      <a:endParaRPr lang="en-GB" sz="1000" b="1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="0" dirty="0" smtClean="0">
                          <a:effectLst/>
                          <a:latin typeface="+mn-lt"/>
                          <a:ea typeface="Times New Roman"/>
                        </a:rPr>
                        <a:t>24</a:t>
                      </a:r>
                      <a:endParaRPr lang="en-GB" sz="1000" b="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+mn-lt"/>
                          <a:ea typeface="Times New Roman"/>
                        </a:rPr>
                        <a:t>1000 or 1024</a:t>
                      </a:r>
                      <a:endParaRPr lang="en-GB" sz="100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GB" sz="1000" b="0" baseline="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/>
                        </a:rPr>
                        <a:t>17 to 24 </a:t>
                      </a:r>
                      <a:endParaRPr lang="en-GB" sz="1000" b="0" baseline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endParaRPr lang="en-GB" sz="1000" b="0" baseline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6"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endParaRPr lang="en-GB" sz="1000" b="1" baseline="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 smtClean="0">
                          <a:effectLst/>
                          <a:latin typeface="+mn-lt"/>
                          <a:ea typeface="Times New Roman"/>
                        </a:rPr>
                        <a:t>5</a:t>
                      </a:r>
                      <a:endParaRPr lang="en-GB" sz="1000" b="1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GB" sz="1000" b="0" baseline="0" dirty="0" smtClean="0">
                          <a:effectLst/>
                          <a:latin typeface="+mn-lt"/>
                          <a:ea typeface="Times New Roman"/>
                        </a:rPr>
                        <a:t>&gt;24</a:t>
                      </a:r>
                      <a:endParaRPr lang="en-GB" sz="1000" b="0" baseline="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+mn-lt"/>
                          <a:ea typeface="Times New Roman"/>
                        </a:rPr>
                        <a:t>&gt;1000</a:t>
                      </a:r>
                      <a:endParaRPr lang="en-GB" sz="100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GB" sz="1000" b="0" baseline="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/>
                        </a:rPr>
                        <a:t>&gt;24</a:t>
                      </a:r>
                      <a:endParaRPr lang="en-GB" sz="1000" b="0" baseline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endParaRPr lang="en-GB" sz="1000" b="0" baseline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GB" sz="1000" b="1" baseline="0" dirty="0" smtClean="0">
                          <a:effectLst/>
                          <a:latin typeface="+mn-lt"/>
                          <a:ea typeface="Times New Roman"/>
                        </a:rPr>
                        <a:t>Electrode Score</a:t>
                      </a:r>
                      <a:endParaRPr lang="en-GB" sz="1000" b="1" baseline="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endParaRPr lang="en-GB" sz="1000" b="1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ts val="17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dirty="0" smtClean="0">
                          <a:effectLst/>
                          <a:latin typeface="+mn-lt"/>
                          <a:ea typeface="Calibri"/>
                          <a:cs typeface="Times New Roman"/>
                        </a:rPr>
                        <a:t>+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 smtClean="0">
                          <a:effectLst/>
                          <a:latin typeface="+mn-lt"/>
                          <a:ea typeface="Times New Roman"/>
                        </a:rPr>
                        <a:t>+</a:t>
                      </a:r>
                      <a:endParaRPr lang="en-GB" sz="1000" b="1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 smtClean="0">
                          <a:effectLst/>
                          <a:latin typeface="+mn-lt"/>
                          <a:ea typeface="Times New Roman"/>
                        </a:rPr>
                        <a:t>+</a:t>
                      </a:r>
                      <a:endParaRPr lang="en-GB" sz="1000" b="1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endParaRPr lang="en-GB" sz="1000" b="1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endParaRPr lang="en-GB" sz="1000" b="1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 smtClean="0">
                          <a:effectLst/>
                          <a:latin typeface="+mn-lt"/>
                          <a:ea typeface="Times New Roman"/>
                        </a:rPr>
                        <a:t>=</a:t>
                      </a:r>
                      <a:endParaRPr lang="en-GB" sz="1000" b="1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ts val="17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1" dirty="0" smtClean="0">
                          <a:latin typeface="+mn-lt"/>
                          <a:ea typeface="Calibri"/>
                          <a:cs typeface="Arial"/>
                        </a:rPr>
                        <a:t>(S)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ts val="17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b="1" dirty="0" smtClean="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</a:tbl>
          </a:graphicData>
        </a:graphic>
      </p:graphicFrame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99277752"/>
              </p:ext>
            </p:extLst>
          </p:nvPr>
        </p:nvGraphicFramePr>
        <p:xfrm>
          <a:off x="476672" y="7788613"/>
          <a:ext cx="5904657" cy="256381"/>
        </p:xfrm>
        <a:graphic>
          <a:graphicData uri="http://schemas.openxmlformats.org/drawingml/2006/table">
            <a:tbl>
              <a:tblPr firstRow="1" firstCol="1" bandRow="1"/>
              <a:tblGrid>
                <a:gridCol w="590465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</a:tblGrid>
              <a:tr h="256381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1" u="sng" dirty="0" smtClean="0"/>
                        <a:t>Section 4</a:t>
                      </a:r>
                      <a:r>
                        <a:rPr lang="en-GB" sz="1200" b="1" u="none" dirty="0" smtClean="0"/>
                        <a:t>: Number of Channels:                    </a:t>
                      </a:r>
                      <a:r>
                        <a:rPr lang="en-GB" sz="1200" b="1" dirty="0" smtClean="0"/>
                        <a:t> (C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304635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88</TotalTime>
  <Words>457</Words>
  <Application>Microsoft Office PowerPoint</Application>
  <PresentationFormat>On-screen Show (4:3)</PresentationFormat>
  <Paragraphs>7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Categorisation of Mobile EEG (CoME)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tegorisation of Mobile EEG (CoME)</dc:title>
  <dc:creator>Tony</dc:creator>
  <cp:lastModifiedBy>Tony</cp:lastModifiedBy>
  <cp:revision>69</cp:revision>
  <cp:lastPrinted>2017-09-01T14:29:16Z</cp:lastPrinted>
  <dcterms:created xsi:type="dcterms:W3CDTF">2016-09-10T10:12:50Z</dcterms:created>
  <dcterms:modified xsi:type="dcterms:W3CDTF">2017-10-17T11:54:13Z</dcterms:modified>
</cp:coreProperties>
</file>